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4876767743384"/>
          <c:y val="2.4508118934990018E-2"/>
          <c:w val="0.86249171379759992"/>
          <c:h val="0.8548024712400693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Sheet3!$AD$5:$AJ$5</c:f>
                <c:numCache>
                  <c:formatCode>General</c:formatCode>
                  <c:ptCount val="7"/>
                  <c:pt idx="0">
                    <c:v>2346.4116708353336</c:v>
                  </c:pt>
                  <c:pt idx="1">
                    <c:v>4471.485895129812</c:v>
                  </c:pt>
                  <c:pt idx="2">
                    <c:v>3938.7998617059347</c:v>
                  </c:pt>
                  <c:pt idx="3">
                    <c:v>4184.0476535522075</c:v>
                  </c:pt>
                  <c:pt idx="4">
                    <c:v>5820.7602750251081</c:v>
                  </c:pt>
                  <c:pt idx="5">
                    <c:v>3562.6245472286391</c:v>
                  </c:pt>
                  <c:pt idx="6">
                    <c:v>5692.403702636796</c:v>
                  </c:pt>
                </c:numCache>
              </c:numRef>
            </c:plus>
            <c:minus>
              <c:numRef>
                <c:f>Sheet3!$AD$5:$AJ$5</c:f>
                <c:numCache>
                  <c:formatCode>General</c:formatCode>
                  <c:ptCount val="7"/>
                  <c:pt idx="0">
                    <c:v>2346.4116708353336</c:v>
                  </c:pt>
                  <c:pt idx="1">
                    <c:v>4471.485895129812</c:v>
                  </c:pt>
                  <c:pt idx="2">
                    <c:v>3938.7998617059347</c:v>
                  </c:pt>
                  <c:pt idx="3">
                    <c:v>4184.0476535522075</c:v>
                  </c:pt>
                  <c:pt idx="4">
                    <c:v>5820.7602750251081</c:v>
                  </c:pt>
                  <c:pt idx="5">
                    <c:v>3562.6245472286391</c:v>
                  </c:pt>
                  <c:pt idx="6">
                    <c:v>5692.4037026367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Sheet3!$AD$3:$AJ$3</c:f>
              <c:strCache>
                <c:ptCount val="7"/>
                <c:pt idx="0">
                  <c:v>May</c:v>
                </c:pt>
                <c:pt idx="1">
                  <c:v>Jun</c:v>
                </c:pt>
                <c:pt idx="2">
                  <c:v>July 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  <c:pt idx="6">
                  <c:v>Nov </c:v>
                </c:pt>
              </c:strCache>
            </c:strRef>
          </c:cat>
          <c:val>
            <c:numRef>
              <c:f>Sheet3!$AD$4:$AJ$4</c:f>
              <c:numCache>
                <c:formatCode>General</c:formatCode>
                <c:ptCount val="7"/>
                <c:pt idx="0">
                  <c:v>12028.064516129032</c:v>
                </c:pt>
                <c:pt idx="1">
                  <c:v>24535.4</c:v>
                </c:pt>
                <c:pt idx="2">
                  <c:v>23004.833333333332</c:v>
                </c:pt>
                <c:pt idx="3">
                  <c:v>21284.785714285714</c:v>
                </c:pt>
                <c:pt idx="4">
                  <c:v>29302.566666666666</c:v>
                </c:pt>
                <c:pt idx="5">
                  <c:v>29580.258064516129</c:v>
                </c:pt>
                <c:pt idx="6">
                  <c:v>3591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23-41FC-AAFE-1138CD2D5A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848475552"/>
        <c:axId val="-848474464"/>
      </c:barChart>
      <c:catAx>
        <c:axId val="-848475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48474464"/>
        <c:crosses val="autoZero"/>
        <c:auto val="1"/>
        <c:lblAlgn val="ctr"/>
        <c:lblOffset val="100"/>
        <c:noMultiLvlLbl val="0"/>
      </c:catAx>
      <c:valAx>
        <c:axId val="-8484744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48475552"/>
        <c:crosses val="autoZero"/>
        <c:crossBetween val="between"/>
        <c:majorUnit val="5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807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83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464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460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92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72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340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834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80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484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518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767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4459139" y="687497"/>
          <a:ext cx="4124326" cy="31622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3350030" y="1903926"/>
            <a:ext cx="20681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tal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w Tests per 1000 people</a:t>
            </a:r>
          </a:p>
        </p:txBody>
      </p:sp>
      <p:sp>
        <p:nvSpPr>
          <p:cNvPr id="6" name="Rectangle 5"/>
          <p:cNvSpPr/>
          <p:nvPr/>
        </p:nvSpPr>
        <p:spPr>
          <a:xfrm>
            <a:off x="1221039" y="4315249"/>
            <a:ext cx="9690166" cy="8732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50000"/>
              </a:lnSpc>
              <a:spcBef>
                <a:spcPts val="1200"/>
              </a:spcBef>
              <a:spcAft>
                <a:spcPts val="1875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2 Fig.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+mn-cs"/>
              </a:rPr>
              <a:t>The total number of tests performed in Pakistan during the given months.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mbria" panose="02040503050406030204" pitchFamily="18" charset="0"/>
                <a:ea typeface="Calibri" panose="020F0502020204030204" pitchFamily="34" charset="0"/>
                <a:cs typeface="+mn-cs"/>
              </a:rPr>
              <a:t>Data Source: https://</a:t>
            </a:r>
            <a:r>
              <a:rPr kumimoji="0" lang="en-US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mbria" panose="02040503050406030204" pitchFamily="18" charset="0"/>
                <a:ea typeface="Calibri" panose="020F0502020204030204" pitchFamily="34" charset="0"/>
                <a:cs typeface="+mn-cs"/>
              </a:rPr>
              <a:t>ourworldindata.org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mbria" panose="02040503050406030204" pitchFamily="18" charset="0"/>
                <a:ea typeface="Calibri" panose="020F0502020204030204" pitchFamily="34" charset="0"/>
                <a:cs typeface="+mn-cs"/>
              </a:rPr>
              <a:t>/coronavirus-testing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4726119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sha Munir</dc:creator>
  <cp:lastModifiedBy>chn off32</cp:lastModifiedBy>
  <cp:revision>3</cp:revision>
  <dcterms:created xsi:type="dcterms:W3CDTF">2021-08-03T13:24:42Z</dcterms:created>
  <dcterms:modified xsi:type="dcterms:W3CDTF">2021-08-04T04:46:27Z</dcterms:modified>
</cp:coreProperties>
</file>